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5" r:id="rId2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Vossen, Jack" initials="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80808"/>
    <a:srgbClr val="0000CC"/>
    <a:srgbClr val="FFCD2F"/>
    <a:srgbClr val="CCE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314" autoAdjust="0"/>
    <p:restoredTop sz="89526" autoAdjust="0"/>
  </p:normalViewPr>
  <p:slideViewPr>
    <p:cSldViewPr snapToGrid="0">
      <p:cViewPr>
        <p:scale>
          <a:sx n="100" d="100"/>
          <a:sy n="100" d="100"/>
        </p:scale>
        <p:origin x="-762" y="-29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pPr>
              <a:defRPr/>
            </a:pPr>
            <a:fld id="{D4E7E4EC-C49D-4190-B24F-1B047866C128}" type="datetimeFigureOut">
              <a:rPr lang="en-GB"/>
              <a:pPr>
                <a:defRPr/>
              </a:pPr>
              <a:t>28/06/201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GB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GB" noProof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pPr>
              <a:defRPr/>
            </a:pPr>
            <a:fld id="{6682832A-CF56-4C18-B170-1647E858C8EA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82849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FBFF737-661F-45A5-841D-1D67A61F4EBE}" type="datetimeFigureOut">
              <a:rPr lang="en-GB"/>
              <a:pPr>
                <a:defRPr/>
              </a:pPr>
              <a:t>28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92D6922-4D2D-4279-9734-16A38CEC08E0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A94CF5E-1E26-42AC-97DE-E8A2C45F8F54}" type="datetimeFigureOut">
              <a:rPr lang="en-GB"/>
              <a:pPr>
                <a:defRPr/>
              </a:pPr>
              <a:t>28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31871C-73AA-4DDF-BB94-C0FFB5C2FBCA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D0AA0B7-DF5C-4AD2-B28C-897D219B1211}" type="datetimeFigureOut">
              <a:rPr lang="en-GB"/>
              <a:pPr>
                <a:defRPr/>
              </a:pPr>
              <a:t>28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184FDC2-3009-4AD4-B99B-294B31683A7F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52A83E-09C6-4589-992F-D78104AE226B}" type="datetimeFigureOut">
              <a:rPr lang="en-GB"/>
              <a:pPr>
                <a:defRPr/>
              </a:pPr>
              <a:t>28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7A45EC9-A378-4F48-B8A9-CFD73C3D486F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C9703AA-71E2-450C-AB1A-73EF55074413}" type="datetimeFigureOut">
              <a:rPr lang="en-GB"/>
              <a:pPr>
                <a:defRPr/>
              </a:pPr>
              <a:t>28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8F4EC9-A0BA-42C0-9FF4-32F777CE59C4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78F9F03-55ED-40C4-9386-6D443357D13E}" type="datetimeFigureOut">
              <a:rPr lang="en-GB"/>
              <a:pPr>
                <a:defRPr/>
              </a:pPr>
              <a:t>28/06/2014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804651C-77E4-4FD2-A10E-BEAF31A97F8F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AD9700-6FC5-4C71-B2F3-4E4C772AB9E1}" type="datetimeFigureOut">
              <a:rPr lang="en-GB"/>
              <a:pPr>
                <a:defRPr/>
              </a:pPr>
              <a:t>28/06/2014</a:t>
            </a:fld>
            <a:endParaRPr lang="en-GB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F117456-3AA0-4919-AE5D-6B6384787636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0614AB9-A2A6-4F38-97D3-98FB7E113C69}" type="datetimeFigureOut">
              <a:rPr lang="en-GB"/>
              <a:pPr>
                <a:defRPr/>
              </a:pPr>
              <a:t>28/06/2014</a:t>
            </a:fld>
            <a:endParaRPr lang="en-GB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B80484-4E36-474B-A922-7D23D10715A2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3337E4E-E222-4DF3-8D44-ABD10C66DDEE}" type="datetimeFigureOut">
              <a:rPr lang="en-GB"/>
              <a:pPr>
                <a:defRPr/>
              </a:pPr>
              <a:t>28/06/2014</a:t>
            </a:fld>
            <a:endParaRPr lang="en-GB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0394E1-3C87-4E6E-9B33-BB332D751066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255B37-178A-4A4B-9A7D-F1958ABB7A53}" type="datetimeFigureOut">
              <a:rPr lang="en-GB"/>
              <a:pPr>
                <a:defRPr/>
              </a:pPr>
              <a:t>28/06/2014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F6EF97-D49F-4390-AB5B-AC31488BA287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A4C5641-0F86-4D46-85D1-0745548602E3}" type="datetimeFigureOut">
              <a:rPr lang="en-GB"/>
              <a:pPr>
                <a:defRPr/>
              </a:pPr>
              <a:t>28/06/2014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A0935C2-69F8-4440-ACFD-4E23F8E4E30C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  <a:endParaRPr lang="en-GB" smtClean="0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69E2B2DB-02B9-4DFB-BCF2-7EB6C3407FD9}" type="datetimeFigureOut">
              <a:rPr lang="en-GB"/>
              <a:pPr>
                <a:defRPr/>
              </a:pPr>
              <a:t>28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E57F817A-13E9-48B5-8D2E-D90317DD37F6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16191062"/>
              </p:ext>
            </p:extLst>
          </p:nvPr>
        </p:nvGraphicFramePr>
        <p:xfrm>
          <a:off x="2051050" y="811213"/>
          <a:ext cx="5616575" cy="3884612"/>
        </p:xfrm>
        <a:graphic>
          <a:graphicData uri="http://schemas.openxmlformats.org/drawingml/2006/table">
            <a:tbl>
              <a:tblPr/>
              <a:tblGrid>
                <a:gridCol w="720725"/>
                <a:gridCol w="647700"/>
                <a:gridCol w="2303463"/>
                <a:gridCol w="811212"/>
                <a:gridCol w="1133475"/>
              </a:tblGrid>
              <a:tr h="379412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Gene ID</a:t>
                      </a:r>
                      <a:endParaRPr kumimoji="0" lang="en-GB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Sequences (5'-3')</a:t>
                      </a:r>
                    </a:p>
                  </a:txBody>
                  <a:tcPr marL="9525" marR="9525" marT="9525" marB="0" anchor="b" horzOverflow="overflow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Fragment </a:t>
                      </a: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size (</a:t>
                      </a:r>
                      <a:r>
                        <a:rPr kumimoji="0" lang="en-GB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bp</a:t>
                      </a:r>
                      <a:r>
                        <a:rPr kumimoji="0" lang="en-GB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)</a:t>
                      </a: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Detection of</a:t>
                      </a:r>
                      <a:endParaRPr kumimoji="0" lang="en-GB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9075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000" b="0" i="1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Rpi-vnt1.1</a:t>
                      </a:r>
                    </a:p>
                  </a:txBody>
                  <a:tcPr marL="9525" marR="9525" marT="9525" marB="0" anchor="b" horzOverflow="overflow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forward</a:t>
                      </a: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ATGAATTATTGTGTTTACAAGACTTG</a:t>
                      </a:r>
                    </a:p>
                  </a:txBody>
                  <a:tcPr marL="9525" marR="9525" marT="9525" marB="0" anchor="b" horzOverflow="overflow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1100</a:t>
                      </a: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T-DNA</a:t>
                      </a:r>
                      <a:endParaRPr kumimoji="0" lang="en-GB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9075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000" b="0" i="1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reverse</a:t>
                      </a: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AGCATTGGCCCAATTATCATTAAC</a:t>
                      </a:r>
                    </a:p>
                  </a:txBody>
                  <a:tcPr marL="9525" marR="9525" marT="9525" marB="0" anchor="b" horzOverflow="overflow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9075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000" b="0" i="1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Rpi-sto1</a:t>
                      </a:r>
                    </a:p>
                  </a:txBody>
                  <a:tcPr marL="9525" marR="9525" marT="9525" marB="0" anchor="b" horzOverflow="overflow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forward</a:t>
                      </a: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ACCAAGGCCACAAGATTCTC</a:t>
                      </a:r>
                    </a:p>
                  </a:txBody>
                  <a:tcPr marL="9525" marR="9525" marT="9525" marB="0" anchor="b" horzOverflow="overflow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890</a:t>
                      </a: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T-DNA</a:t>
                      </a: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9075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000" b="0" i="1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reverse</a:t>
                      </a: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CCTGCGGTTCGGTTAATACA</a:t>
                      </a:r>
                    </a:p>
                  </a:txBody>
                  <a:tcPr marL="9525" marR="9525" marT="9525" marB="0" anchor="b" horzOverflow="overflow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9075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tetA</a:t>
                      </a:r>
                      <a:endParaRPr kumimoji="0" lang="en-GB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forward</a:t>
                      </a: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CTGCTAGGTAGCCCGATACG</a:t>
                      </a:r>
                    </a:p>
                  </a:txBody>
                  <a:tcPr marL="9525" marR="9525" marT="9525" marB="0" anchor="b" horzOverflow="overflow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396</a:t>
                      </a:r>
                      <a:endParaRPr kumimoji="0" lang="en-GB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Vector backbone</a:t>
                      </a:r>
                      <a:endParaRPr kumimoji="0" lang="en-GB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9075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reverse</a:t>
                      </a: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CCGAGAACATTGGTTCCTGT</a:t>
                      </a:r>
                    </a:p>
                  </a:txBody>
                  <a:tcPr marL="9525" marR="9525" marT="9525" marB="0" anchor="b" horzOverflow="overflow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9075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trfA</a:t>
                      </a:r>
                      <a:endParaRPr kumimoji="0" lang="en-GB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forward</a:t>
                      </a: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CGTCAACAAGGACGTGAAGA</a:t>
                      </a:r>
                    </a:p>
                  </a:txBody>
                  <a:tcPr marL="9525" marR="9525" marT="9525" marB="0" anchor="b" horzOverflow="overflow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146</a:t>
                      </a:r>
                      <a:endParaRPr kumimoji="0" lang="en-GB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Vector backbone</a:t>
                      </a:r>
                      <a:endParaRPr kumimoji="0" lang="en-GB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9075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000" b="0" i="1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reverse</a:t>
                      </a: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CCTGGCAAAGCTCGTAGAAC</a:t>
                      </a:r>
                    </a:p>
                  </a:txBody>
                  <a:tcPr marL="9525" marR="9525" marT="9525" marB="0" anchor="b" horzOverflow="overflow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9075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NPTIII</a:t>
                      </a:r>
                    </a:p>
                  </a:txBody>
                  <a:tcPr marL="9525" marR="9525" marT="9525" marB="0" anchor="b" horzOverflow="overflow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forward</a:t>
                      </a: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GAAAGCTGCCTGTTCCAAAG</a:t>
                      </a:r>
                    </a:p>
                  </a:txBody>
                  <a:tcPr marL="9525" marR="9525" marT="9525" marB="0" anchor="ctr" horzOverflow="overflow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162</a:t>
                      </a:r>
                      <a:endParaRPr kumimoji="0" lang="en-GB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Vector backbone</a:t>
                      </a:r>
                      <a:endParaRPr kumimoji="0" lang="en-GB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9075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reverse</a:t>
                      </a: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GAAAGAGCCTGATGCACTCC</a:t>
                      </a:r>
                    </a:p>
                  </a:txBody>
                  <a:tcPr marL="9525" marR="9525" marT="9525" marB="0" anchor="ctr" horzOverflow="overflow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9075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ColE1</a:t>
                      </a:r>
                      <a:endParaRPr kumimoji="0" lang="en-GB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forward</a:t>
                      </a: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ATAAGTGCCCTGCGGTATTG</a:t>
                      </a:r>
                    </a:p>
                  </a:txBody>
                  <a:tcPr marL="9525" marR="9525" marT="9525" marB="0" anchor="b" horzOverflow="overflow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246</a:t>
                      </a:r>
                      <a:endParaRPr kumimoji="0" lang="en-GB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Vector backbone</a:t>
                      </a:r>
                      <a:endParaRPr kumimoji="0" lang="en-GB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9075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000" b="0" i="1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reverse</a:t>
                      </a: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GCAGCCCTGGTTAAAAACAA</a:t>
                      </a:r>
                    </a:p>
                  </a:txBody>
                  <a:tcPr marL="9525" marR="9525" marT="9525" marB="0" anchor="b" horzOverflow="overflow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9075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oriV</a:t>
                      </a:r>
                      <a:endParaRPr kumimoji="0" lang="en-GB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forward</a:t>
                      </a: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TGCGGCGAGCGGTATCAG</a:t>
                      </a:r>
                    </a:p>
                  </a:txBody>
                  <a:tcPr marL="9525" marR="9525" marT="9525" marB="0" anchor="b" horzOverflow="overflow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1045</a:t>
                      </a:r>
                      <a:endParaRPr kumimoji="0" lang="en-GB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Vector backbone</a:t>
                      </a:r>
                      <a:endParaRPr kumimoji="0" lang="en-GB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9075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reverse</a:t>
                      </a: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CTTCTTGATGGAGCGCATGGG</a:t>
                      </a:r>
                    </a:p>
                  </a:txBody>
                  <a:tcPr marL="9525" marR="9525" marT="9525" marB="0" anchor="b" horzOverflow="overflow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9075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traJ</a:t>
                      </a:r>
                      <a:endParaRPr kumimoji="0" lang="en-GB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forward</a:t>
                      </a: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ACGAAGAGCGATTGAGGAAA</a:t>
                      </a:r>
                    </a:p>
                  </a:txBody>
                  <a:tcPr marL="9525" marR="9525" marT="9525" marB="0" anchor="ctr" horzOverflow="overflow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260</a:t>
                      </a:r>
                      <a:endParaRPr kumimoji="0" lang="en-GB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Vector backbone</a:t>
                      </a:r>
                      <a:endParaRPr kumimoji="0" lang="en-GB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9075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reverse</a:t>
                      </a: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charset="0"/>
                        </a:rPr>
                        <a:t>CAAGCTCGTCCTGCTTCTCT</a:t>
                      </a:r>
                    </a:p>
                  </a:txBody>
                  <a:tcPr marL="9525" marR="9525" marT="9525" marB="0" anchor="ctr" horzOverflow="overflow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charset="0"/>
                      </a:endParaRPr>
                    </a:p>
                  </a:txBody>
                  <a:tcPr marL="9525" marR="9525" marT="9525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14459" name="Rectangle 26"/>
          <p:cNvSpPr>
            <a:spLocks noChangeArrowheads="1"/>
          </p:cNvSpPr>
          <p:nvPr/>
        </p:nvSpPr>
        <p:spPr bwMode="auto">
          <a:xfrm>
            <a:off x="2632075" y="361950"/>
            <a:ext cx="4530725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>
            <a:spAutoFit/>
          </a:bodyPr>
          <a:lstStyle/>
          <a:p>
            <a:pPr>
              <a:tabLst>
                <a:tab pos="685800" algn="l"/>
              </a:tabLst>
            </a:pPr>
            <a:r>
              <a:rPr lang="en-GB" altLang="zh-TW" sz="1200" b="1" dirty="0">
                <a:latin typeface="Times New Roman" pitchFamily="18" charset="0"/>
              </a:rPr>
              <a:t>Additional file </a:t>
            </a:r>
            <a:r>
              <a:rPr lang="en-GB" altLang="zh-TW" sz="1200" b="1" dirty="0" smtClean="0">
                <a:latin typeface="Times New Roman" pitchFamily="18" charset="0"/>
              </a:rPr>
              <a:t>4 </a:t>
            </a:r>
            <a:r>
              <a:rPr lang="en-GB" altLang="zh-TW" sz="1200" b="1" dirty="0">
                <a:latin typeface="Times New Roman" pitchFamily="18" charset="0"/>
              </a:rPr>
              <a:t>– Primers used for PCR analysis of </a:t>
            </a:r>
            <a:r>
              <a:rPr lang="en-GB" altLang="zh-TW" sz="1200" b="1" dirty="0" err="1">
                <a:latin typeface="Times New Roman" pitchFamily="18" charset="0"/>
              </a:rPr>
              <a:t>transformants</a:t>
            </a:r>
            <a:r>
              <a:rPr lang="en-GB" altLang="zh-TW" b="1" dirty="0"/>
              <a:t> </a:t>
            </a:r>
            <a:endParaRPr lang="en-US" altLang="zh-TW" sz="1100" dirty="0">
              <a:latin typeface="Verdana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993</TotalTime>
  <Words>88</Words>
  <Application>Microsoft Office PowerPoint</Application>
  <PresentationFormat>On-screen Show (4:3)</PresentationFormat>
  <Paragraphs>6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Wageningen U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, Kwang Ryong</dc:creator>
  <cp:lastModifiedBy>jjaurigue</cp:lastModifiedBy>
  <cp:revision>1020</cp:revision>
  <dcterms:created xsi:type="dcterms:W3CDTF">2012-07-22T10:01:28Z</dcterms:created>
  <dcterms:modified xsi:type="dcterms:W3CDTF">2014-06-28T10:32:20Z</dcterms:modified>
</cp:coreProperties>
</file>